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2128B-A2FF-4A93-9D29-5E1D0E9EB7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07DE4-7C54-4860-984E-20CA3F55C0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D49A2B-506B-42DF-840B-40B9972991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63700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919840"/>
            <a:ext cx="19044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7BC94-A28D-4A96-B4E4-80006CB193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6F5D29-B300-4919-9A99-AED56B0668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345859-82FE-410E-854C-CF0205F07C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C4B87-BA9A-4874-85E8-E1479BB6D9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D0E44-1315-4B88-A2B0-5A2DC33914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527040"/>
            <a:ext cx="5914800" cy="887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CB307-72B6-41FE-B7FF-6DC43413D5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75A80-2784-4305-994B-11D4586E96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91984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08AB2-2932-400E-BB4E-06162BD0A0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637000"/>
            <a:ext cx="288612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919840"/>
            <a:ext cx="5914800" cy="299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E68BF-581F-4022-A732-4C6AB316E6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527040"/>
            <a:ext cx="5914800" cy="191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637000"/>
            <a:ext cx="5914800" cy="6284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9182160"/>
            <a:ext cx="2314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9182160"/>
            <a:ext cx="15429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177807-8314-4600-A668-E580D93B6E07}" type="slidenum">
              <a:rPr b="0" lang="en-GB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8760" y="1434960"/>
          <a:ext cx="6699240" cy="4332600"/>
        </p:xfrm>
        <a:graphic>
          <a:graphicData uri="http://schemas.openxmlformats.org/drawingml/2006/table">
            <a:tbl>
              <a:tblPr/>
              <a:tblGrid>
                <a:gridCol w="1184400"/>
                <a:gridCol w="2604960"/>
                <a:gridCol w="2909880"/>
              </a:tblGrid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vers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38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C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GGACTCCCAGCACA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TTCTTCCATTCTTTTCTCTCACACA 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XO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TACGAGTGGATGGTGCG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ACTATGCAGTGACAGGTTG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ZH2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TGCGACTGAGACAGCTCAA 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CTGTTTCCATTCTTGG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5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α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ATCAGGTCCACCTTCTAGAA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GCCAGACGAGACCAATC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A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CGAGGGCTGGTTTCCTTG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CTCTGCAATTCTGCGA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5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GGAAGGGTACAGCCAA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CAGCCGGCGCAA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5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XO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1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CTTGAAGCCGAGTTGTGG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GGCTCTGACTGCTTACTG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446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XO3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GAATGCTGGCATTTCCTCT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CACAAATTGCCTCGACCT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XO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AGCCGAAGACAGCACAGAC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GCGTGCGTTTGTTTATGTT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97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i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OXO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imers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TTGTACGCGTCGAACTAGC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’-TCAACGACCCCATACACAAA-3’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5"/>
          <p:cNvSpPr/>
          <p:nvPr/>
        </p:nvSpPr>
        <p:spPr>
          <a:xfrm>
            <a:off x="4826520" y="96296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2T13:43:38Z</dcterms:created>
  <dc:creator>Gong, Chun</dc:creator>
  <dc:description/>
  <dc:language>en-US</dc:language>
  <cp:lastModifiedBy>Satish.d</cp:lastModifiedBy>
  <cp:lastPrinted>2015-11-05T12:17:29Z</cp:lastPrinted>
  <dcterms:modified xsi:type="dcterms:W3CDTF">2016-03-17T14:11:04Z</dcterms:modified>
  <cp:revision>971</cp:revision>
  <dc:subject/>
  <dc:title>Regulation of FOXO3a by BRCA1</dc:title>
</cp:coreProperties>
</file>